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5" r:id="rId10"/>
    <p:sldId id="266" r:id="rId11"/>
  </p:sldIdLst>
  <p:sldSz cx="16200438" cy="125999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56" d="100"/>
          <a:sy n="56" d="100"/>
        </p:scale>
        <p:origin x="36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5033" y="2062083"/>
            <a:ext cx="13770372" cy="4386662"/>
          </a:xfrm>
        </p:spPr>
        <p:txBody>
          <a:bodyPr anchor="b"/>
          <a:lstStyle>
            <a:lvl1pPr algn="ctr">
              <a:defRPr sz="1063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25055" y="6617911"/>
            <a:ext cx="12150329" cy="3042080"/>
          </a:xfrm>
        </p:spPr>
        <p:txBody>
          <a:bodyPr/>
          <a:lstStyle>
            <a:lvl1pPr marL="0" indent="0" algn="ctr">
              <a:buNone/>
              <a:defRPr sz="4252"/>
            </a:lvl1pPr>
            <a:lvl2pPr marL="810021" indent="0" algn="ctr">
              <a:buNone/>
              <a:defRPr sz="3543"/>
            </a:lvl2pPr>
            <a:lvl3pPr marL="1620042" indent="0" algn="ctr">
              <a:buNone/>
              <a:defRPr sz="3189"/>
            </a:lvl3pPr>
            <a:lvl4pPr marL="2430064" indent="0" algn="ctr">
              <a:buNone/>
              <a:defRPr sz="2835"/>
            </a:lvl4pPr>
            <a:lvl5pPr marL="3240085" indent="0" algn="ctr">
              <a:buNone/>
              <a:defRPr sz="2835"/>
            </a:lvl5pPr>
            <a:lvl6pPr marL="4050106" indent="0" algn="ctr">
              <a:buNone/>
              <a:defRPr sz="2835"/>
            </a:lvl6pPr>
            <a:lvl7pPr marL="4860127" indent="0" algn="ctr">
              <a:buNone/>
              <a:defRPr sz="2835"/>
            </a:lvl7pPr>
            <a:lvl8pPr marL="5670149" indent="0" algn="ctr">
              <a:buNone/>
              <a:defRPr sz="2835"/>
            </a:lvl8pPr>
            <a:lvl9pPr marL="6480170" indent="0" algn="ctr">
              <a:buNone/>
              <a:defRPr sz="2835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C23A5-4EFF-4239-B93C-9BE80391CC10}" type="datetimeFigureOut">
              <a:rPr lang="ko-KR" altLang="en-US" smtClean="0"/>
              <a:t>2021-02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2E67E-A6FC-4153-B81E-567987546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1994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C23A5-4EFF-4239-B93C-9BE80391CC10}" type="datetimeFigureOut">
              <a:rPr lang="ko-KR" altLang="en-US" smtClean="0"/>
              <a:t>2021-02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2E67E-A6FC-4153-B81E-567987546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093589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593440" y="670833"/>
            <a:ext cx="3493219" cy="1067790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3781" y="670833"/>
            <a:ext cx="10277153" cy="1067790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C23A5-4EFF-4239-B93C-9BE80391CC10}" type="datetimeFigureOut">
              <a:rPr lang="ko-KR" altLang="en-US" smtClean="0"/>
              <a:t>2021-02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2E67E-A6FC-4153-B81E-567987546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55292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C23A5-4EFF-4239-B93C-9BE80391CC10}" type="datetimeFigureOut">
              <a:rPr lang="ko-KR" altLang="en-US" smtClean="0"/>
              <a:t>2021-02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2E67E-A6FC-4153-B81E-567987546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9483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5343" y="3141251"/>
            <a:ext cx="13972878" cy="5241244"/>
          </a:xfrm>
        </p:spPr>
        <p:txBody>
          <a:bodyPr anchor="b"/>
          <a:lstStyle>
            <a:lvl1pPr>
              <a:defRPr sz="1063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5343" y="8432079"/>
            <a:ext cx="13972878" cy="2756246"/>
          </a:xfrm>
        </p:spPr>
        <p:txBody>
          <a:bodyPr/>
          <a:lstStyle>
            <a:lvl1pPr marL="0" indent="0">
              <a:buNone/>
              <a:defRPr sz="4252">
                <a:solidFill>
                  <a:schemeClr val="tx1"/>
                </a:solidFill>
              </a:defRPr>
            </a:lvl1pPr>
            <a:lvl2pPr marL="810021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2pPr>
            <a:lvl3pPr marL="1620042" indent="0">
              <a:buNone/>
              <a:defRPr sz="3189">
                <a:solidFill>
                  <a:schemeClr val="tx1">
                    <a:tint val="75000"/>
                  </a:schemeClr>
                </a:solidFill>
              </a:defRPr>
            </a:lvl3pPr>
            <a:lvl4pPr marL="2430064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4pPr>
            <a:lvl5pPr marL="3240085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5pPr>
            <a:lvl6pPr marL="4050106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6pPr>
            <a:lvl7pPr marL="486012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7pPr>
            <a:lvl8pPr marL="5670149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8pPr>
            <a:lvl9pPr marL="6480170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C23A5-4EFF-4239-B93C-9BE80391CC10}" type="datetimeFigureOut">
              <a:rPr lang="ko-KR" altLang="en-US" smtClean="0"/>
              <a:t>2021-02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2E67E-A6FC-4153-B81E-567987546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3754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3780" y="3354163"/>
            <a:ext cx="6885186" cy="799457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01472" y="3354163"/>
            <a:ext cx="6885186" cy="799457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C23A5-4EFF-4239-B93C-9BE80391CC10}" type="datetimeFigureOut">
              <a:rPr lang="ko-KR" altLang="en-US" smtClean="0"/>
              <a:t>2021-02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2E67E-A6FC-4153-B81E-567987546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3132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670836"/>
            <a:ext cx="13972878" cy="243541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892" y="3088748"/>
            <a:ext cx="6853544" cy="1513748"/>
          </a:xfrm>
        </p:spPr>
        <p:txBody>
          <a:bodyPr anchor="b"/>
          <a:lstStyle>
            <a:lvl1pPr marL="0" indent="0">
              <a:buNone/>
              <a:defRPr sz="4252" b="1"/>
            </a:lvl1pPr>
            <a:lvl2pPr marL="810021" indent="0">
              <a:buNone/>
              <a:defRPr sz="3543" b="1"/>
            </a:lvl2pPr>
            <a:lvl3pPr marL="1620042" indent="0">
              <a:buNone/>
              <a:defRPr sz="3189" b="1"/>
            </a:lvl3pPr>
            <a:lvl4pPr marL="2430064" indent="0">
              <a:buNone/>
              <a:defRPr sz="2835" b="1"/>
            </a:lvl4pPr>
            <a:lvl5pPr marL="3240085" indent="0">
              <a:buNone/>
              <a:defRPr sz="2835" b="1"/>
            </a:lvl5pPr>
            <a:lvl6pPr marL="4050106" indent="0">
              <a:buNone/>
              <a:defRPr sz="2835" b="1"/>
            </a:lvl6pPr>
            <a:lvl7pPr marL="4860127" indent="0">
              <a:buNone/>
              <a:defRPr sz="2835" b="1"/>
            </a:lvl7pPr>
            <a:lvl8pPr marL="5670149" indent="0">
              <a:buNone/>
              <a:defRPr sz="2835" b="1"/>
            </a:lvl8pPr>
            <a:lvl9pPr marL="6480170" indent="0">
              <a:buNone/>
              <a:defRPr sz="2835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5892" y="4602496"/>
            <a:ext cx="6853544" cy="676957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01473" y="3088748"/>
            <a:ext cx="6887296" cy="1513748"/>
          </a:xfrm>
        </p:spPr>
        <p:txBody>
          <a:bodyPr anchor="b"/>
          <a:lstStyle>
            <a:lvl1pPr marL="0" indent="0">
              <a:buNone/>
              <a:defRPr sz="4252" b="1"/>
            </a:lvl1pPr>
            <a:lvl2pPr marL="810021" indent="0">
              <a:buNone/>
              <a:defRPr sz="3543" b="1"/>
            </a:lvl2pPr>
            <a:lvl3pPr marL="1620042" indent="0">
              <a:buNone/>
              <a:defRPr sz="3189" b="1"/>
            </a:lvl3pPr>
            <a:lvl4pPr marL="2430064" indent="0">
              <a:buNone/>
              <a:defRPr sz="2835" b="1"/>
            </a:lvl4pPr>
            <a:lvl5pPr marL="3240085" indent="0">
              <a:buNone/>
              <a:defRPr sz="2835" b="1"/>
            </a:lvl5pPr>
            <a:lvl6pPr marL="4050106" indent="0">
              <a:buNone/>
              <a:defRPr sz="2835" b="1"/>
            </a:lvl6pPr>
            <a:lvl7pPr marL="4860127" indent="0">
              <a:buNone/>
              <a:defRPr sz="2835" b="1"/>
            </a:lvl7pPr>
            <a:lvl8pPr marL="5670149" indent="0">
              <a:buNone/>
              <a:defRPr sz="2835" b="1"/>
            </a:lvl8pPr>
            <a:lvl9pPr marL="6480170" indent="0">
              <a:buNone/>
              <a:defRPr sz="2835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01473" y="4602496"/>
            <a:ext cx="6887296" cy="676957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C23A5-4EFF-4239-B93C-9BE80391CC10}" type="datetimeFigureOut">
              <a:rPr lang="ko-KR" altLang="en-US" smtClean="0"/>
              <a:t>2021-02-2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2E67E-A6FC-4153-B81E-567987546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3438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C23A5-4EFF-4239-B93C-9BE80391CC10}" type="datetimeFigureOut">
              <a:rPr lang="ko-KR" altLang="en-US" smtClean="0"/>
              <a:t>2021-02-2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2E67E-A6FC-4153-B81E-567987546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7398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C23A5-4EFF-4239-B93C-9BE80391CC10}" type="datetimeFigureOut">
              <a:rPr lang="ko-KR" altLang="en-US" smtClean="0"/>
              <a:t>2021-02-2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2E67E-A6FC-4153-B81E-567987546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83547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839999"/>
            <a:ext cx="5225063" cy="2939997"/>
          </a:xfrm>
        </p:spPr>
        <p:txBody>
          <a:bodyPr anchor="b"/>
          <a:lstStyle>
            <a:lvl1pPr>
              <a:defRPr sz="5669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887296" y="1814168"/>
            <a:ext cx="8201472" cy="8954158"/>
          </a:xfrm>
        </p:spPr>
        <p:txBody>
          <a:bodyPr/>
          <a:lstStyle>
            <a:lvl1pPr>
              <a:defRPr sz="5669"/>
            </a:lvl1pPr>
            <a:lvl2pPr>
              <a:defRPr sz="4961"/>
            </a:lvl2pPr>
            <a:lvl3pPr>
              <a:defRPr sz="4252"/>
            </a:lvl3pPr>
            <a:lvl4pPr>
              <a:defRPr sz="3543"/>
            </a:lvl4pPr>
            <a:lvl5pPr>
              <a:defRPr sz="3543"/>
            </a:lvl5pPr>
            <a:lvl6pPr>
              <a:defRPr sz="3543"/>
            </a:lvl6pPr>
            <a:lvl7pPr>
              <a:defRPr sz="3543"/>
            </a:lvl7pPr>
            <a:lvl8pPr>
              <a:defRPr sz="3543"/>
            </a:lvl8pPr>
            <a:lvl9pPr>
              <a:defRPr sz="3543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0" y="3779996"/>
            <a:ext cx="5225063" cy="7002911"/>
          </a:xfrm>
        </p:spPr>
        <p:txBody>
          <a:bodyPr/>
          <a:lstStyle>
            <a:lvl1pPr marL="0" indent="0">
              <a:buNone/>
              <a:defRPr sz="2835"/>
            </a:lvl1pPr>
            <a:lvl2pPr marL="810021" indent="0">
              <a:buNone/>
              <a:defRPr sz="2480"/>
            </a:lvl2pPr>
            <a:lvl3pPr marL="1620042" indent="0">
              <a:buNone/>
              <a:defRPr sz="2126"/>
            </a:lvl3pPr>
            <a:lvl4pPr marL="2430064" indent="0">
              <a:buNone/>
              <a:defRPr sz="1772"/>
            </a:lvl4pPr>
            <a:lvl5pPr marL="3240085" indent="0">
              <a:buNone/>
              <a:defRPr sz="1772"/>
            </a:lvl5pPr>
            <a:lvl6pPr marL="4050106" indent="0">
              <a:buNone/>
              <a:defRPr sz="1772"/>
            </a:lvl6pPr>
            <a:lvl7pPr marL="4860127" indent="0">
              <a:buNone/>
              <a:defRPr sz="1772"/>
            </a:lvl7pPr>
            <a:lvl8pPr marL="5670149" indent="0">
              <a:buNone/>
              <a:defRPr sz="1772"/>
            </a:lvl8pPr>
            <a:lvl9pPr marL="6480170" indent="0">
              <a:buNone/>
              <a:defRPr sz="1772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C23A5-4EFF-4239-B93C-9BE80391CC10}" type="datetimeFigureOut">
              <a:rPr lang="ko-KR" altLang="en-US" smtClean="0"/>
              <a:t>2021-02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2E67E-A6FC-4153-B81E-567987546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99723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839999"/>
            <a:ext cx="5225063" cy="2939997"/>
          </a:xfrm>
        </p:spPr>
        <p:txBody>
          <a:bodyPr anchor="b"/>
          <a:lstStyle>
            <a:lvl1pPr>
              <a:defRPr sz="5669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887296" y="1814168"/>
            <a:ext cx="8201472" cy="8954158"/>
          </a:xfrm>
        </p:spPr>
        <p:txBody>
          <a:bodyPr anchor="t"/>
          <a:lstStyle>
            <a:lvl1pPr marL="0" indent="0">
              <a:buNone/>
              <a:defRPr sz="5669"/>
            </a:lvl1pPr>
            <a:lvl2pPr marL="810021" indent="0">
              <a:buNone/>
              <a:defRPr sz="4961"/>
            </a:lvl2pPr>
            <a:lvl3pPr marL="1620042" indent="0">
              <a:buNone/>
              <a:defRPr sz="4252"/>
            </a:lvl3pPr>
            <a:lvl4pPr marL="2430064" indent="0">
              <a:buNone/>
              <a:defRPr sz="3543"/>
            </a:lvl4pPr>
            <a:lvl5pPr marL="3240085" indent="0">
              <a:buNone/>
              <a:defRPr sz="3543"/>
            </a:lvl5pPr>
            <a:lvl6pPr marL="4050106" indent="0">
              <a:buNone/>
              <a:defRPr sz="3543"/>
            </a:lvl6pPr>
            <a:lvl7pPr marL="4860127" indent="0">
              <a:buNone/>
              <a:defRPr sz="3543"/>
            </a:lvl7pPr>
            <a:lvl8pPr marL="5670149" indent="0">
              <a:buNone/>
              <a:defRPr sz="3543"/>
            </a:lvl8pPr>
            <a:lvl9pPr marL="6480170" indent="0">
              <a:buNone/>
              <a:defRPr sz="3543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0" y="3779996"/>
            <a:ext cx="5225063" cy="7002911"/>
          </a:xfrm>
        </p:spPr>
        <p:txBody>
          <a:bodyPr/>
          <a:lstStyle>
            <a:lvl1pPr marL="0" indent="0">
              <a:buNone/>
              <a:defRPr sz="2835"/>
            </a:lvl1pPr>
            <a:lvl2pPr marL="810021" indent="0">
              <a:buNone/>
              <a:defRPr sz="2480"/>
            </a:lvl2pPr>
            <a:lvl3pPr marL="1620042" indent="0">
              <a:buNone/>
              <a:defRPr sz="2126"/>
            </a:lvl3pPr>
            <a:lvl4pPr marL="2430064" indent="0">
              <a:buNone/>
              <a:defRPr sz="1772"/>
            </a:lvl4pPr>
            <a:lvl5pPr marL="3240085" indent="0">
              <a:buNone/>
              <a:defRPr sz="1772"/>
            </a:lvl5pPr>
            <a:lvl6pPr marL="4050106" indent="0">
              <a:buNone/>
              <a:defRPr sz="1772"/>
            </a:lvl6pPr>
            <a:lvl7pPr marL="4860127" indent="0">
              <a:buNone/>
              <a:defRPr sz="1772"/>
            </a:lvl7pPr>
            <a:lvl8pPr marL="5670149" indent="0">
              <a:buNone/>
              <a:defRPr sz="1772"/>
            </a:lvl8pPr>
            <a:lvl9pPr marL="6480170" indent="0">
              <a:buNone/>
              <a:defRPr sz="1772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8C23A5-4EFF-4239-B93C-9BE80391CC10}" type="datetimeFigureOut">
              <a:rPr lang="ko-KR" altLang="en-US" smtClean="0"/>
              <a:t>2021-02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2E67E-A6FC-4153-B81E-567987546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2141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3780" y="670836"/>
            <a:ext cx="13972878" cy="2435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3780" y="3354163"/>
            <a:ext cx="13972878" cy="7994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3780" y="11678325"/>
            <a:ext cx="3645099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8C23A5-4EFF-4239-B93C-9BE80391CC10}" type="datetimeFigureOut">
              <a:rPr lang="ko-KR" altLang="en-US" smtClean="0"/>
              <a:t>2021-02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66395" y="11678325"/>
            <a:ext cx="5467648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41559" y="11678325"/>
            <a:ext cx="3645099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A2E67E-A6FC-4153-B81E-5679875464E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9260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620042" rtl="0" eaLnBrk="1" latinLnBrk="1" hangingPunct="1">
        <a:lnSpc>
          <a:spcPct val="90000"/>
        </a:lnSpc>
        <a:spcBef>
          <a:spcPct val="0"/>
        </a:spcBef>
        <a:buNone/>
        <a:defRPr sz="779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5011" indent="-405011" algn="l" defTabSz="1620042" rtl="0" eaLnBrk="1" latinLnBrk="1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sz="4961" kern="1200">
          <a:solidFill>
            <a:schemeClr val="tx1"/>
          </a:solidFill>
          <a:latin typeface="+mn-lt"/>
          <a:ea typeface="+mn-ea"/>
          <a:cs typeface="+mn-cs"/>
        </a:defRPr>
      </a:lvl1pPr>
      <a:lvl2pPr marL="1215032" indent="-405011" algn="l" defTabSz="1620042" rtl="0" eaLnBrk="1" latinLnBrk="1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2pPr>
      <a:lvl3pPr marL="2025053" indent="-405011" algn="l" defTabSz="1620042" rtl="0" eaLnBrk="1" latinLnBrk="1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835074" indent="-405011" algn="l" defTabSz="1620042" rtl="0" eaLnBrk="1" latinLnBrk="1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4pPr>
      <a:lvl5pPr marL="3645096" indent="-405011" algn="l" defTabSz="1620042" rtl="0" eaLnBrk="1" latinLnBrk="1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5pPr>
      <a:lvl6pPr marL="4455117" indent="-405011" algn="l" defTabSz="1620042" rtl="0" eaLnBrk="1" latinLnBrk="1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6pPr>
      <a:lvl7pPr marL="5265138" indent="-405011" algn="l" defTabSz="1620042" rtl="0" eaLnBrk="1" latinLnBrk="1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7pPr>
      <a:lvl8pPr marL="6075159" indent="-405011" algn="l" defTabSz="1620042" rtl="0" eaLnBrk="1" latinLnBrk="1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8pPr>
      <a:lvl9pPr marL="6885181" indent="-405011" algn="l" defTabSz="1620042" rtl="0" eaLnBrk="1" latinLnBrk="1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0042" rtl="0" eaLnBrk="1" latinLnBrk="1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1pPr>
      <a:lvl2pPr marL="810021" algn="l" defTabSz="1620042" rtl="0" eaLnBrk="1" latinLnBrk="1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2pPr>
      <a:lvl3pPr marL="1620042" algn="l" defTabSz="1620042" rtl="0" eaLnBrk="1" latinLnBrk="1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3pPr>
      <a:lvl4pPr marL="2430064" algn="l" defTabSz="1620042" rtl="0" eaLnBrk="1" latinLnBrk="1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4pPr>
      <a:lvl5pPr marL="3240085" algn="l" defTabSz="1620042" rtl="0" eaLnBrk="1" latinLnBrk="1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5pPr>
      <a:lvl6pPr marL="4050106" algn="l" defTabSz="1620042" rtl="0" eaLnBrk="1" latinLnBrk="1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6pPr>
      <a:lvl7pPr marL="4860127" algn="l" defTabSz="1620042" rtl="0" eaLnBrk="1" latinLnBrk="1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7pPr>
      <a:lvl8pPr marL="5670149" algn="l" defTabSz="1620042" rtl="0" eaLnBrk="1" latinLnBrk="1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8pPr>
      <a:lvl9pPr marL="6480170" algn="l" defTabSz="1620042" rtl="0" eaLnBrk="1" latinLnBrk="1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09580"/>
            <a:ext cx="16200438" cy="10580828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189781" y="258792"/>
            <a:ext cx="8057072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ko-KR" sz="2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001100 </a:t>
            </a:r>
            <a:r>
              <a:rPr lang="en-US" altLang="ko-KR" sz="2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bolic </a:t>
            </a:r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hways</a:t>
            </a:r>
            <a:endParaRPr lang="ko-KR" altLang="en-US" sz="2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690478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0269" y="1418431"/>
            <a:ext cx="6819900" cy="976312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89781" y="258792"/>
            <a:ext cx="6435306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ko-KR" sz="2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00010 Glycolysis/Gluconeogenesis</a:t>
            </a:r>
            <a:endParaRPr lang="ko-KR" altLang="en-US" sz="2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6363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8944" y="1337469"/>
            <a:ext cx="12782550" cy="992505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89780" y="258792"/>
            <a:ext cx="5296619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ko-KR" sz="2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04010 MAPK </a:t>
            </a:r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aling pathway</a:t>
            </a:r>
            <a:endParaRPr lang="ko-KR" altLang="en-US" sz="2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85498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0031" y="2628106"/>
            <a:ext cx="10620375" cy="734377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89781" y="258792"/>
            <a:ext cx="9765102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ko-KR" sz="2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04020 Calcium </a:t>
            </a:r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aling pathway</a:t>
            </a:r>
            <a:endParaRPr lang="ko-KR" altLang="en-US" sz="2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20227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1381" y="1951831"/>
            <a:ext cx="11877675" cy="869632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89781" y="258792"/>
            <a:ext cx="6901132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ko-KR" sz="2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04810 Regulation </a:t>
            </a:r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actin cytoskeleton</a:t>
            </a:r>
            <a:endParaRPr lang="ko-KR" altLang="en-US" sz="2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18731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8544" y="2218531"/>
            <a:ext cx="11563350" cy="816292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89781" y="258792"/>
            <a:ext cx="9851366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ko-KR" sz="2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04141 Protein </a:t>
            </a:r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cessing in endoplasmic reticulum</a:t>
            </a:r>
            <a:endParaRPr lang="ko-KR" altLang="en-US" sz="2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346623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9419" y="1542256"/>
            <a:ext cx="12801600" cy="951547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89781" y="258792"/>
            <a:ext cx="6435306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ko-KR" sz="2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04144 Endocytosis</a:t>
            </a:r>
            <a:endParaRPr lang="ko-KR" altLang="en-US" sz="2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35675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3306" y="2747169"/>
            <a:ext cx="11553825" cy="710565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89781" y="258792"/>
            <a:ext cx="6435306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ko-KR" sz="2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04510 Focal </a:t>
            </a:r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hesion</a:t>
            </a:r>
            <a:endParaRPr lang="ko-KR" altLang="en-US" sz="2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253197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3188" y="0"/>
            <a:ext cx="10294061" cy="1259998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89780" y="258792"/>
            <a:ext cx="8695427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ko-KR" sz="2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00520 Amino </a:t>
            </a:r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gar and nucleotide sugar metabolism</a:t>
            </a:r>
            <a:endParaRPr lang="ko-KR" altLang="en-US" sz="2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754846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1781" y="1523206"/>
            <a:ext cx="13096875" cy="955357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89781" y="258792"/>
            <a:ext cx="6435306" cy="4770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ko-KR" sz="2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04142 Lysosome</a:t>
            </a:r>
            <a:endParaRPr lang="ko-KR" altLang="en-US" sz="2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74216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</TotalTime>
  <Words>38</Words>
  <Application>Microsoft Office PowerPoint</Application>
  <PresentationFormat>사용자 지정</PresentationFormat>
  <Paragraphs>10</Paragraphs>
  <Slides>10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0</vt:i4>
      </vt:variant>
    </vt:vector>
  </HeadingPairs>
  <TitlesOfParts>
    <vt:vector size="16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4</cp:revision>
  <dcterms:created xsi:type="dcterms:W3CDTF">2021-02-23T05:40:56Z</dcterms:created>
  <dcterms:modified xsi:type="dcterms:W3CDTF">2021-02-23T06:29:36Z</dcterms:modified>
</cp:coreProperties>
</file>